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9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20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4C501A-47CA-FFBA-0497-1B973CE687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34EB585-C87C-BDE0-0DBB-A3B650C509E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7BFE0B-809A-31E2-DA48-B3A58329F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6B907-F092-456E-96A3-A725F950762A}" type="datetimeFigureOut">
              <a:rPr lang="en-US" smtClean="0"/>
              <a:t>12/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C3AF96-28D4-E804-43A3-DAB2A1EA12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4F58A5-5569-A56E-9FDE-BB68B6827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758F7-3FBC-48DA-BDD8-D400EB56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9871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EDEBC9-6636-0FBD-9792-40AF8C7B0C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65D770-63D0-3D00-DAD8-0153738A91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E4B8B0-81D7-AEFF-4569-1B5BF28C7F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6B907-F092-456E-96A3-A725F950762A}" type="datetimeFigureOut">
              <a:rPr lang="en-US" smtClean="0"/>
              <a:t>12/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8E2CB8-F03B-E643-D709-642C68CB33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DBE395-7437-78F7-EBE5-AC177081DD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758F7-3FBC-48DA-BDD8-D400EB56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505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68A2D6D-51AE-D313-867C-D0D3791C54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D5D0268-CE26-5149-4763-58AB6E6BF0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42C363-74BA-0090-7AA5-AE1225038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6B907-F092-456E-96A3-A725F950762A}" type="datetimeFigureOut">
              <a:rPr lang="en-US" smtClean="0"/>
              <a:t>12/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7348C6-1F75-3FBF-E07D-7C8B552A94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DC6658-DB04-D6A7-7E19-BE34D93AE0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758F7-3FBC-48DA-BDD8-D400EB56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3594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2683A7-2C3B-DF56-86BF-EC801E0B68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FA6AAF-22CC-0D52-926A-73BD480168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640227-243F-ACAF-57F6-9072E87DD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6B907-F092-456E-96A3-A725F950762A}" type="datetimeFigureOut">
              <a:rPr lang="en-US" smtClean="0"/>
              <a:t>12/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62EC2B-A8A9-A1CD-2D31-E4EDEF097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8ADE1F-D1D7-0622-850A-B9F5381833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758F7-3FBC-48DA-BDD8-D400EB56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696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6C0321-7C7E-FDCD-E32D-A1E9168568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0866B5-1056-FAD3-6698-DA6B2AB405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168E41-4C0F-5F32-E8A5-C7B86186EF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6B907-F092-456E-96A3-A725F950762A}" type="datetimeFigureOut">
              <a:rPr lang="en-US" smtClean="0"/>
              <a:t>12/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A693AB-F99D-2439-15C8-D55483B2F1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A735D9-5CC3-2C1E-F46C-FEA04436EF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758F7-3FBC-48DA-BDD8-D400EB56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871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AF57DB-457C-48E4-35CD-CA42032A51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FFFB58-B9B2-53CD-32F8-857301F3C5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5CB4E5-B58E-EFF8-E927-CCF4B22991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A1D54E-1E83-E76C-C00F-C223CD97B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6B907-F092-456E-96A3-A725F950762A}" type="datetimeFigureOut">
              <a:rPr lang="en-US" smtClean="0"/>
              <a:t>12/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4AABCD-E299-11F2-969F-9789081EC1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E21BD2-C474-2BD9-D925-9A8CC1FB8C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758F7-3FBC-48DA-BDD8-D400EB56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4688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010A80-29AA-B96C-7986-0D308C5B05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2FA7C0-2487-6C8D-BF92-B3FA55C871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F0210A-2933-751D-19C2-4063563EAB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C248A08-ED47-AE7D-4E4F-B9CA315BA7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E6B1C54-4F74-A63D-2CBC-D1F9EDEDD7F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F3D8BA4-7A4C-0923-5BED-3441184C6C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6B907-F092-456E-96A3-A725F950762A}" type="datetimeFigureOut">
              <a:rPr lang="en-US" smtClean="0"/>
              <a:t>12/7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AE8D887-DA56-2BA7-EF69-E6631F0227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3903862-E4CF-558B-3719-A864B54737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758F7-3FBC-48DA-BDD8-D400EB56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056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EBD5EB-010B-4FAA-9A2A-07C6DCA70B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1FA6820-CF52-64F4-CDDD-E9A1F4387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6B907-F092-456E-96A3-A725F950762A}" type="datetimeFigureOut">
              <a:rPr lang="en-US" smtClean="0"/>
              <a:t>12/7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3E71864-EE48-C3F1-FA43-5B7416B1D7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D511150-E1A8-7797-AA06-832217311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758F7-3FBC-48DA-BDD8-D400EB56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078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9EDB809-CE41-DD9C-30EA-949241A660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6B907-F092-456E-96A3-A725F950762A}" type="datetimeFigureOut">
              <a:rPr lang="en-US" smtClean="0"/>
              <a:t>12/7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59BC992-E972-503B-DF40-83E1E61C8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38756C7-2A45-2438-64AB-9AB69867F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758F7-3FBC-48DA-BDD8-D400EB56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1275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80B37D-0DD7-890E-547D-40FD5A4932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F5C11F-8F41-23DB-0386-581EFAEFF9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CF002E-B90E-4086-A7BD-C4C440FD82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85CB10-B29C-F9F4-DEF5-8E11C81DC6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6B907-F092-456E-96A3-A725F950762A}" type="datetimeFigureOut">
              <a:rPr lang="en-US" smtClean="0"/>
              <a:t>12/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0FC0FA-686B-EEC8-0BD7-28B45A7F9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F8BFD6-B04E-565D-289C-F6D4A4593E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758F7-3FBC-48DA-BDD8-D400EB56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137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3E60B1-4E8A-3676-3A49-83F9DA56F7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C592E4A-B832-2164-F04C-22EF81CB17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D4DD8E-E595-DCA7-4504-CD8E5186BB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66661E-E56C-F640-9090-A209FA6D83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B6B907-F092-456E-96A3-A725F950762A}" type="datetimeFigureOut">
              <a:rPr lang="en-US" smtClean="0"/>
              <a:t>12/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C0EBB5-981A-FE55-A9B7-18936DAC1A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55537A-F05D-C069-0C53-97D75A258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758F7-3FBC-48DA-BDD8-D400EB56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6316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03A8D3A-81A6-2A7F-DB3C-74AABE28AD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F43B84-6E06-69F0-B867-E5068F32A7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9F833B-2310-315A-C95C-64B2A73499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B6B907-F092-456E-96A3-A725F950762A}" type="datetimeFigureOut">
              <a:rPr lang="en-US" smtClean="0"/>
              <a:t>12/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363E5A-6612-D9CD-7664-BE659E883D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2791EB-4179-D7AF-9661-C7572BA5D7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8758F7-3FBC-48DA-BDD8-D400EB56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553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361981E-45CD-3656-C9BD-007193C52F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0800000">
            <a:off x="386675" y="876725"/>
            <a:ext cx="5378489" cy="338229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A9A39FE-DE92-7A05-9982-FBEA7A8D653B}"/>
              </a:ext>
            </a:extLst>
          </p:cNvPr>
          <p:cNvSpPr txBox="1"/>
          <p:nvPr/>
        </p:nvSpPr>
        <p:spPr>
          <a:xfrm>
            <a:off x="464812" y="299866"/>
            <a:ext cx="35445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Full unedited blot from Figure 5D</a:t>
            </a:r>
          </a:p>
        </p:txBody>
      </p:sp>
      <p:sp>
        <p:nvSpPr>
          <p:cNvPr id="10" name="Right Brace 9">
            <a:extLst>
              <a:ext uri="{FF2B5EF4-FFF2-40B4-BE49-F238E27FC236}">
                <a16:creationId xmlns:a16="http://schemas.microsoft.com/office/drawing/2014/main" id="{B4EF469C-4CC5-E465-ADE6-0FA3C45FD9C5}"/>
              </a:ext>
            </a:extLst>
          </p:cNvPr>
          <p:cNvSpPr/>
          <p:nvPr/>
        </p:nvSpPr>
        <p:spPr>
          <a:xfrm rot="16200000">
            <a:off x="1665885" y="106549"/>
            <a:ext cx="342065" cy="1659355"/>
          </a:xfrm>
          <a:prstGeom prst="rightBrac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3DB36C6-A69C-91CD-5D0C-72BC2410C4C8}"/>
              </a:ext>
            </a:extLst>
          </p:cNvPr>
          <p:cNvSpPr txBox="1"/>
          <p:nvPr/>
        </p:nvSpPr>
        <p:spPr>
          <a:xfrm>
            <a:off x="1007240" y="551365"/>
            <a:ext cx="17411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Helvetica" pitchFamily="2" charset="0"/>
              </a:rPr>
              <a:t>Lanes used for the figure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A308926A-E904-493D-9996-60E3521FC24C}"/>
              </a:ext>
            </a:extLst>
          </p:cNvPr>
          <p:cNvSpPr/>
          <p:nvPr/>
        </p:nvSpPr>
        <p:spPr>
          <a:xfrm>
            <a:off x="939144" y="1107259"/>
            <a:ext cx="1749929" cy="3122702"/>
          </a:xfrm>
          <a:prstGeom prst="rect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9942B2D-5B96-E8A2-A320-90CD189B1EFC}"/>
              </a:ext>
            </a:extLst>
          </p:cNvPr>
          <p:cNvSpPr txBox="1"/>
          <p:nvPr/>
        </p:nvSpPr>
        <p:spPr>
          <a:xfrm rot="16200000">
            <a:off x="772309" y="4508037"/>
            <a:ext cx="8451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Helvetica" pitchFamily="2" charset="0"/>
              </a:rPr>
              <a:t>Control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9915F53-5A3F-DF20-9768-762E0F261536}"/>
              </a:ext>
            </a:extLst>
          </p:cNvPr>
          <p:cNvSpPr txBox="1"/>
          <p:nvPr/>
        </p:nvSpPr>
        <p:spPr>
          <a:xfrm rot="16200000">
            <a:off x="848069" y="4738571"/>
            <a:ext cx="13532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Helvetica" pitchFamily="2" charset="0"/>
              </a:rPr>
              <a:t>Vector (50µl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8F94E20-44BD-3D40-048E-4DEB5F67BC1B}"/>
              </a:ext>
            </a:extLst>
          </p:cNvPr>
          <p:cNvSpPr txBox="1"/>
          <p:nvPr/>
        </p:nvSpPr>
        <p:spPr>
          <a:xfrm rot="16200000">
            <a:off x="733875" y="5192502"/>
            <a:ext cx="226363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600" dirty="0">
                <a:latin typeface="Helvetica" pitchFamily="2" charset="0"/>
              </a:rPr>
              <a:t>Syntaxin virus (10µl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0DF7755-5FA1-D385-2EE2-D882849515C1}"/>
              </a:ext>
            </a:extLst>
          </p:cNvPr>
          <p:cNvSpPr txBox="1"/>
          <p:nvPr/>
        </p:nvSpPr>
        <p:spPr>
          <a:xfrm rot="16200000">
            <a:off x="1356240" y="5192499"/>
            <a:ext cx="226363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600" dirty="0">
                <a:latin typeface="Helvetica" pitchFamily="2" charset="0"/>
              </a:rPr>
              <a:t>Syntaxin virus (50µl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2D0EB92-7DEE-2036-C3B2-A0E562F03B82}"/>
              </a:ext>
            </a:extLst>
          </p:cNvPr>
          <p:cNvSpPr txBox="1"/>
          <p:nvPr/>
        </p:nvSpPr>
        <p:spPr>
          <a:xfrm rot="16200000">
            <a:off x="1052347" y="5207032"/>
            <a:ext cx="226363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600" dirty="0">
                <a:latin typeface="Helvetica" pitchFamily="2" charset="0"/>
              </a:rPr>
              <a:t>Syntaxin virus (25µl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61434B3-5DFD-D516-B188-9E0617EFC4D0}"/>
              </a:ext>
            </a:extLst>
          </p:cNvPr>
          <p:cNvSpPr txBox="1"/>
          <p:nvPr/>
        </p:nvSpPr>
        <p:spPr>
          <a:xfrm>
            <a:off x="5765164" y="3554685"/>
            <a:ext cx="1261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Syntaxin 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ACED74B-D439-6A71-BB15-EC7433AE8D9A}"/>
              </a:ext>
            </a:extLst>
          </p:cNvPr>
          <p:cNvSpPr txBox="1"/>
          <p:nvPr/>
        </p:nvSpPr>
        <p:spPr>
          <a:xfrm>
            <a:off x="5765164" y="2299278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VIN</a:t>
            </a:r>
          </a:p>
        </p:txBody>
      </p:sp>
    </p:spTree>
    <p:extLst>
      <p:ext uri="{BB962C8B-B14F-4D97-AF65-F5344CB8AC3E}">
        <p14:creationId xmlns:p14="http://schemas.microsoft.com/office/powerpoint/2010/main" val="5255731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1F7F92C-0425-2649-9FA7-FD3278413C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0800000">
            <a:off x="447894" y="809142"/>
            <a:ext cx="5054860" cy="341012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5DC1F7E-11B7-BA49-35DE-2DEACE48F1BC}"/>
              </a:ext>
            </a:extLst>
          </p:cNvPr>
          <p:cNvSpPr txBox="1"/>
          <p:nvPr/>
        </p:nvSpPr>
        <p:spPr>
          <a:xfrm>
            <a:off x="447894" y="260109"/>
            <a:ext cx="36984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Full unedited blot from Figure S1C</a:t>
            </a:r>
          </a:p>
        </p:txBody>
      </p:sp>
      <p:sp>
        <p:nvSpPr>
          <p:cNvPr id="4" name="Right Brace 3">
            <a:extLst>
              <a:ext uri="{FF2B5EF4-FFF2-40B4-BE49-F238E27FC236}">
                <a16:creationId xmlns:a16="http://schemas.microsoft.com/office/drawing/2014/main" id="{93F5ABD6-233C-8177-5F2F-95E43215B13F}"/>
              </a:ext>
            </a:extLst>
          </p:cNvPr>
          <p:cNvSpPr/>
          <p:nvPr/>
        </p:nvSpPr>
        <p:spPr>
          <a:xfrm rot="16200000">
            <a:off x="4062928" y="57428"/>
            <a:ext cx="342065" cy="1749929"/>
          </a:xfrm>
          <a:prstGeom prst="rightBrac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52D87B2-18C0-FD18-33B2-8631BF27A7F8}"/>
              </a:ext>
            </a:extLst>
          </p:cNvPr>
          <p:cNvSpPr txBox="1"/>
          <p:nvPr/>
        </p:nvSpPr>
        <p:spPr>
          <a:xfrm>
            <a:off x="3415027" y="547532"/>
            <a:ext cx="17411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Helvetica" pitchFamily="2" charset="0"/>
              </a:rPr>
              <a:t>Lanes used for the figure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CE8300F-1AED-3186-2241-C1FB82806014}"/>
              </a:ext>
            </a:extLst>
          </p:cNvPr>
          <p:cNvSpPr/>
          <p:nvPr/>
        </p:nvSpPr>
        <p:spPr>
          <a:xfrm>
            <a:off x="3358996" y="1096566"/>
            <a:ext cx="1749929" cy="3122702"/>
          </a:xfrm>
          <a:prstGeom prst="rect">
            <a:avLst/>
          </a:prstGeom>
          <a:noFill/>
          <a:ln w="2857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C5B8D9F-2337-FDA1-B56D-1A58BF2F0619}"/>
              </a:ext>
            </a:extLst>
          </p:cNvPr>
          <p:cNvSpPr txBox="1"/>
          <p:nvPr/>
        </p:nvSpPr>
        <p:spPr>
          <a:xfrm rot="16200000">
            <a:off x="3712216" y="5152739"/>
            <a:ext cx="226363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600" dirty="0">
                <a:latin typeface="Helvetica" pitchFamily="2" charset="0"/>
              </a:rPr>
              <a:t>Syntaxin virus (10µl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2F14384-093D-E592-64D0-86A628591EC1}"/>
              </a:ext>
            </a:extLst>
          </p:cNvPr>
          <p:cNvSpPr txBox="1"/>
          <p:nvPr/>
        </p:nvSpPr>
        <p:spPr>
          <a:xfrm rot="16200000">
            <a:off x="2938707" y="4726641"/>
            <a:ext cx="13532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600" dirty="0">
                <a:latin typeface="Helvetica" pitchFamily="2" charset="0"/>
              </a:rPr>
              <a:t>Vector (10µl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660C7FF-8535-6A59-3301-D90BABEED2FC}"/>
              </a:ext>
            </a:extLst>
          </p:cNvPr>
          <p:cNvSpPr txBox="1"/>
          <p:nvPr/>
        </p:nvSpPr>
        <p:spPr>
          <a:xfrm rot="16200000">
            <a:off x="3345351" y="5152740"/>
            <a:ext cx="226363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600" dirty="0">
                <a:latin typeface="Helvetica" pitchFamily="2" charset="0"/>
              </a:rPr>
              <a:t>Syntaxin virus (3µl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CC9B6FC-A2F4-0DCD-FDE3-52A3D99811A9}"/>
              </a:ext>
            </a:extLst>
          </p:cNvPr>
          <p:cNvSpPr txBox="1"/>
          <p:nvPr/>
        </p:nvSpPr>
        <p:spPr>
          <a:xfrm rot="16200000">
            <a:off x="2951522" y="5152739"/>
            <a:ext cx="226363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1600" dirty="0">
                <a:latin typeface="Helvetica" pitchFamily="2" charset="0"/>
              </a:rPr>
              <a:t>Syntaxin virus (1µl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8AB8DC7-924C-3B83-224A-54A668343543}"/>
              </a:ext>
            </a:extLst>
          </p:cNvPr>
          <p:cNvSpPr txBox="1"/>
          <p:nvPr/>
        </p:nvSpPr>
        <p:spPr>
          <a:xfrm>
            <a:off x="5502754" y="2878824"/>
            <a:ext cx="1261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Syntaxin 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41689F5-018C-F01B-D610-79CF89FB1E76}"/>
              </a:ext>
            </a:extLst>
          </p:cNvPr>
          <p:cNvSpPr txBox="1"/>
          <p:nvPr/>
        </p:nvSpPr>
        <p:spPr>
          <a:xfrm>
            <a:off x="5502754" y="140475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VIN</a:t>
            </a:r>
          </a:p>
        </p:txBody>
      </p:sp>
    </p:spTree>
    <p:extLst>
      <p:ext uri="{BB962C8B-B14F-4D97-AF65-F5344CB8AC3E}">
        <p14:creationId xmlns:p14="http://schemas.microsoft.com/office/powerpoint/2010/main" val="3495052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67</Words>
  <Application>Microsoft Macintosh PowerPoint</Application>
  <PresentationFormat>Widescreen</PresentationFormat>
  <Paragraphs>1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hrenbacher, Jill C</dc:creator>
  <cp:lastModifiedBy>Sapio, Matt (NIH/CC/SURG) [C]</cp:lastModifiedBy>
  <cp:revision>4</cp:revision>
  <dcterms:created xsi:type="dcterms:W3CDTF">2023-12-07T20:30:56Z</dcterms:created>
  <dcterms:modified xsi:type="dcterms:W3CDTF">2023-12-07T23:31:41Z</dcterms:modified>
</cp:coreProperties>
</file>